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357F65-84F1-43A5-894E-D95B543120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70845-190E-4C25-9D8B-C3FC330534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F3337-5D5B-488B-AD23-5173674482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55AB7-FBB7-47DF-8FCA-67D7C4B5FA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1E7AA-80EC-4E6A-AA2B-4034E9A2B4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3291A-69DA-44E4-BFC5-CBD1914B76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F06F6-90FE-44CE-BEB8-C97E031ADA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30E07-B09B-4221-BEAB-D63D2FA8CC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7809B-A0A2-4F52-B93C-5645C644E6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F02D7F-B266-4B9B-8682-7B6DD86052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C7981-3782-4030-A6DD-CBE8049656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CFFA8-8613-455B-8F58-527F0C1A75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EE5CA9-CD8D-4411-9430-9A059B600F31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1"/>
          <p:cNvSpPr/>
          <p:nvPr/>
        </p:nvSpPr>
        <p:spPr>
          <a:xfrm>
            <a:off x="0" y="9352080"/>
            <a:ext cx="75596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. 3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DFS rate (a) and OS rate (b) of in 32 Pairs of Matched ICC Patients after surgery according to 1:1 PSM between N1 and Nx Patient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图片 1" descr="g_name~ 131"/>
          <p:cNvPicPr/>
          <p:nvPr/>
        </p:nvPicPr>
        <p:blipFill>
          <a:blip r:embed="rId1"/>
          <a:stretch/>
        </p:blipFill>
        <p:spPr>
          <a:xfrm>
            <a:off x="915840" y="4624560"/>
            <a:ext cx="4211640" cy="33699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3" name=""/>
          <p:cNvGraphicFramePr/>
          <p:nvPr/>
        </p:nvGraphicFramePr>
        <p:xfrm>
          <a:off x="915840" y="3505320"/>
          <a:ext cx="4562640" cy="1339560"/>
        </p:xfrm>
        <a:graphic>
          <a:graphicData uri="http://schemas.openxmlformats.org/drawingml/2006/table">
            <a:tbl>
              <a:tblPr/>
              <a:tblGrid>
                <a:gridCol w="833760"/>
                <a:gridCol w="1247760"/>
                <a:gridCol w="834840"/>
                <a:gridCol w="797040"/>
                <a:gridCol w="849240"/>
              </a:tblGrid>
              <a:tr h="51804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2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 (35.7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 (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 (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804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2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 (34.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 (9.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 (9.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915840" y="8211960"/>
          <a:ext cx="4562640" cy="1265400"/>
        </p:xfrm>
        <a:graphic>
          <a:graphicData uri="http://schemas.openxmlformats.org/drawingml/2006/table">
            <a:tbl>
              <a:tblPr/>
              <a:tblGrid>
                <a:gridCol w="833760"/>
                <a:gridCol w="1247760"/>
                <a:gridCol w="834840"/>
                <a:gridCol w="797040"/>
                <a:gridCol w="849240"/>
              </a:tblGrid>
              <a:tr h="51804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2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 (39.5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 (13.8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 (13.8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804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2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 (46.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 (19.5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 (7.8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45" name="组合 4"/>
          <p:cNvGrpSpPr/>
          <p:nvPr/>
        </p:nvGrpSpPr>
        <p:grpSpPr>
          <a:xfrm>
            <a:off x="915840" y="-7920"/>
            <a:ext cx="4211640" cy="3368520"/>
            <a:chOff x="915840" y="-7920"/>
            <a:chExt cx="4211640" cy="3368520"/>
          </a:xfrm>
        </p:grpSpPr>
        <p:pic>
          <p:nvPicPr>
            <p:cNvPr id="46" name="图片 1" descr="g_name~ 122"/>
            <p:cNvPicPr/>
            <p:nvPr/>
          </p:nvPicPr>
          <p:blipFill>
            <a:blip r:embed="rId2"/>
            <a:stretch/>
          </p:blipFill>
          <p:spPr>
            <a:xfrm>
              <a:off x="915840" y="-7920"/>
              <a:ext cx="4211640" cy="33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图片 1" descr="g_name~ 131"/>
            <p:cNvPicPr/>
            <p:nvPr/>
          </p:nvPicPr>
          <p:blipFill>
            <a:blip r:embed="rId3"/>
            <a:srcRect l="51041" t="9777" r="38834" b="81918"/>
            <a:stretch/>
          </p:blipFill>
          <p:spPr>
            <a:xfrm>
              <a:off x="3065400" y="355320"/>
              <a:ext cx="426600" cy="2800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8-19T08:35:12Z</dcterms:created>
  <dc:creator>Administrator</dc:creator>
  <dc:description/>
  <dc:language>en-US</dc:language>
  <cp:lastModifiedBy>Jiu-Lin Song</cp:lastModifiedBy>
  <dcterms:modified xsi:type="dcterms:W3CDTF">2023-10-21T17:37:13Z</dcterms:modified>
  <cp:revision>5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69</vt:lpwstr>
  </property>
</Properties>
</file>